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014" y="384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DFD06-0182-417A-AC33-F68858B5DD02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52C5C-E9C6-4880-AF61-F2332B9433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4"/>
          <p:cNvSpPr>
            <a:spLocks noChangeArrowheads="1"/>
          </p:cNvSpPr>
          <p:nvPr/>
        </p:nvSpPr>
        <p:spPr bwMode="auto">
          <a:xfrm>
            <a:off x="496888" y="179389"/>
            <a:ext cx="6172200" cy="9669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1430" tIns="45714" rIns="91430" bIns="45714"/>
          <a:lstStyle/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endParaRPr lang="zh-TW" altLang="en-US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-239</a:t>
            </a: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				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   t</a:t>
            </a: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-236	</a:t>
            </a: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tgccctgaagccactgagtgtctcacactgcctgtggtatgctactgccccccttaca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-177	</a:t>
            </a: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cttcccggtgcttcctgcccctgttactcttccctgctctgctcctgtctcccttc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-118	</a:t>
            </a: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cttttgcctgtgctgctcctgcccctgccattgtcataaggattattgccctgctcag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-59	</a:t>
            </a:r>
            <a:r>
              <a:rPr lang="zh-TW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gcactgaggatttccatgccagtatctgcctttttgtctcctatctgaaagctatagg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M   T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S   D   W   L   W   S   T   G   I   W   A   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+15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1	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G ACC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CC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TCC GAC TGG CTT TGG AGC ACT GGG ATC TGG GCA CT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                  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      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   L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R   P   A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Q   L   S   C   D   L 	+3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46	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CC CTT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T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T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AGA CCT GCT GCA GCC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CAG CTG TCA TGT GAC C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L   R   V   L   K   M   Q   E   D   L   C   T   E   A   L	+45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91	CTT AGG GTC TTA AAA ATG CAA GAA GAC CTC TGT ACT GAG GCT CTA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A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E   N   V   S   R   N   Y   W   P   E   G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C	+6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136	GCA GCT GAA AAT GTG TCA AGG AAT TAC TGG CCA GAG GGA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G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TGT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V   G   K   W   D   K   I   S   C   W   P   S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S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A   L	+75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181	GTT GGG AAG TGG GAT AAG ATT AGC TGC TGG CCT TCC TCT GCC C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G   E   T   V   T   I   P   C   P   E   I   L   Q   G   F 	+9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226	GGA GAA ACC GTT ACC ATT CCC TGC CCC GAG ATC CTG CAG GGC T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T   D   Q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Q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G   S   L   Y   R   N   C   T   K   D   G 	+105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271	ACA GAT CAG CAA GGG TCC TTA TAC AGA AAC TGT ACG AAA GAT GG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W   S   T   R   F   P   S   I   D   V   A   C   G   Y   D	+12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316	TGG TCT ACA AGG TTC CCT TCA ATA GAT GTG GCG TGT GGA TAT GAT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A   N   I   T   D   N   V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F   M   H   L   K   T 	+135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361	GCC AAT ATA ACA GAC AAT GTG GTC TAT TTC ATG CAC CTG AAG ACT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L   Y   T   A   G   Y   G   T   S   L   A   S   L   A   L	+15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406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G TAC ACC GCT GGC TAT GGA ACC TCT CTG GCT TCC CTT GCC CTT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A   L   A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A   S   F   R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R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L   R   C   T   R	+165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451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CC CTG GCT CTC CTG GCA TCA TTC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AGG CGA CTG CGT TGC ACT CG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N   Y   I   H   M   H   L   F   V   S   F   I   L   R   A	+18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496	AAC TAC ATC CAC ATG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AC CTG TTT GTG TCT TTC ATC CTA CGT GCA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M   S   I   F   I   K   D   A   V   L   Y   S   T   E   D	+195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541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G TCC ATC TTC ATA AAG GAT GCA GTT CT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TAC TCC ACA GAA GAC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I   N   H   C   N   I   Y   S   T   D   C   S   F   L   M	+210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586	ATC AAC CAT TGC AAC ATC TAC TCA ACC GAT TGT AGC TTC CTT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G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I   F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Q   Y   C   I   M   A   N   Y   S   W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22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631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T TTC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TC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CAG TAC TGC ATC ATG GCC AAC TAC AGC TGG CTG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G</a:t>
            </a:r>
            <a:endParaRPr lang="en-US" altLang="zh-TW" sz="1000" u="sng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V   E   G   L   Y   L   H   T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V   I   S   F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240 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676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TG GAA GGA CTG TA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CTC CAT ACC CTG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GTA ATC TCC TTC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TC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S   E   W   K   Y   F   C   W   Y   I   A   L   G   W   G 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25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721	TCA GAG TGG AAA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AC TTC TGC TGG TAC ATC GCC CTG GGC TGG GGA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S   P   L   V   F   I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A   W   A   V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C   R   H   L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27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766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CT CCA TTG GTT TTC ATT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T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GCC TGG GCT GT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TGC CGC CAT CTT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Y   E   N   I   G   C   W   D   I   N   S   N   A   S   I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28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811	TAT GAG AAC ATT GGG TGC TGG GAC ATT AAT TCC AAT GCT AGT A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W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W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I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R   G   P   V   I   L   S   I   F   I   N	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0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856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GG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GG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ATA ATC CGA GGC CCA GTC ATT CTG TCC ATT TTT ATT AAT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F   I   L   F   V   R   I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R   I   L   M   K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K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L	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1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901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TT ATC CTC TTT GTG AGG ATC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C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CGC ATT CTG ATG AAG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A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TTG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K   A   T   D   V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S   R   N   D   F   G   Q   Y   K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3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946  AAG GCG ACA GAT GTG GTT TCG AGG AAT GAT TTT GGG CAG TAC AAG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R   L   A   R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S   T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I   P   L   F   G   V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4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991	AGG CTG GCA AGA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CC ACT CTG CTA CTT ATC CCA CTC TTT GGG G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H   Y   M   V   F   A   F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P   E   D   V   S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S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G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6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036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AT TAT ATG GTC TTT GCA TTC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TC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CC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GAA GAT GTG AGC AGT GGA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T   V   E   I   R   L   S   F   E   L   T   L   G   S   F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7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081	ACG GTT GAG ATC CGC CTG TCA TTT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AG TTA ACA CTG GGC TCG T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Q   G   F   V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A   V   L   Y   C   F   L   N   G   E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39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126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AG GGC TTT GTG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TG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GCC GTG CTC TAC TGT TTC CTC AAT GGA GAG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V   Q   S   E   I   Q   R   K   W   R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R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W   H   F   R 	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40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171	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T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CAA AGT GAG ATC CAG AGG AAG TGG CGC AGA TGG CAT TTT AGG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E   Y   F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R   Q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Q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 K   N   S   I   V   S   N 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42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216	GAA TAT TTC CTG TTA CGG CAG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A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AAG AAC TCA ATA GTG AGC AAT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G   V   T   V   L   T   Q   V   L   P   V   S   R   S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S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	+</a:t>
            </a:r>
            <a:r>
              <a:rPr lang="en-US" altLang="zh-TW" sz="1000" dirty="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435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261	GGG GTC ACT GTA CTT ACA CAA GTT TTG CCA GTC AGC CGG AGC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GC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N   K   E   Q   R   N   T   P   A   Q   K   T   S   V   I	</a:t>
            </a:r>
            <a:r>
              <a:rPr lang="en-US" altLang="zh-TW" sz="100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+</a:t>
            </a:r>
            <a:r>
              <a:rPr lang="en-US" altLang="zh-TW" sz="1000" smtClean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450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306	AAT AAG GAG CAG AGG AAT ACA CCA GCC CAG AAA ACT AGT GTC ATC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	 *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351	</a:t>
            </a:r>
            <a:r>
              <a:rPr lang="en-US" altLang="zh-TW" sz="1000" dirty="0" err="1">
                <a:solidFill>
                  <a:srgbClr val="000000"/>
                </a:solidFill>
                <a:latin typeface="Courier New" pitchFamily="49" charset="0"/>
                <a:ea typeface="新細明體" pitchFamily="18" charset="-120"/>
                <a:cs typeface="Courier New" pitchFamily="49" charset="0"/>
              </a:rPr>
              <a:t>TAAattggaggctcttcgttctcctacaatcaaacatttatcagaaacccaggatgctt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410	</a:t>
            </a:r>
            <a:r>
              <a:rPr lang="en-US" altLang="zh-TW" sz="1000" dirty="0" err="1">
                <a:solidFill>
                  <a:srgbClr val="000000"/>
                </a:solidFill>
                <a:latin typeface="Courier New" pitchFamily="49" charset="0"/>
                <a:ea typeface="新細明體" pitchFamily="18" charset="-120"/>
                <a:cs typeface="Courier New" pitchFamily="49" charset="0"/>
              </a:rPr>
              <a:t>ctagatctcggcatattcaaccgatcagtccaattgggaccctgagtcaagccaacaaa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469	</a:t>
            </a:r>
            <a:r>
              <a:rPr lang="en-US" altLang="zh-TW" sz="1000" dirty="0" err="1">
                <a:solidFill>
                  <a:srgbClr val="000000"/>
                </a:solidFill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ttgggtcaacnaactaggggccacatatctacagggaaatccagaattatctagatc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	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528	</a:t>
            </a:r>
            <a:r>
              <a:rPr lang="en-US" altLang="zh-TW" sz="1000" dirty="0" err="1">
                <a:solidFill>
                  <a:srgbClr val="000000"/>
                </a:solidFill>
                <a:latin typeface="Courier New" pitchFamily="49" charset="0"/>
                <a:ea typeface="新細明體" pitchFamily="18" charset="-120"/>
                <a:cs typeface="Courier New" pitchFamily="49" charset="0"/>
              </a:rPr>
              <a:t>ggggaatgtcaatctaactggtatcatgattaaagagaataacatagggtcaactaaaa</a:t>
            </a:r>
            <a:endParaRPr lang="en-US" altLang="zh-TW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1587	</a:t>
            </a:r>
            <a:r>
              <a:rPr lang="en-US" altLang="zh-TW" sz="1000" dirty="0" err="1">
                <a:solidFill>
                  <a:srgbClr val="000000"/>
                </a:solidFill>
                <a:latin typeface="Courier New" pitchFamily="49" charset="0"/>
                <a:ea typeface="新細明體" pitchFamily="18" charset="-120"/>
                <a:cs typeface="Courier New" pitchFamily="49" charset="0"/>
              </a:rPr>
              <a:t>aaaaaaaaaaaaaaa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  <a:cs typeface="Courier New" pitchFamily="49" charset="0"/>
              </a:rPr>
              <a:t>  </a:t>
            </a:r>
          </a:p>
          <a:p>
            <a:pPr marL="609600" indent="-609600">
              <a:lnSpc>
                <a:spcPct val="40000"/>
              </a:lnSpc>
              <a:spcBef>
                <a:spcPct val="20000"/>
              </a:spcBef>
            </a:pPr>
            <a:r>
              <a:rPr lang="en-US" altLang="zh-TW" sz="1000" dirty="0">
                <a:latin typeface="新細明體" pitchFamily="18" charset="-120"/>
                <a:ea typeface="新細明體" pitchFamily="18" charset="-120"/>
                <a:cs typeface="Courier New" pitchFamily="49" charset="0"/>
              </a:rPr>
              <a:t>	</a:t>
            </a:r>
            <a:endParaRPr lang="zh-TW" altLang="en-US" sz="1000" dirty="0">
              <a:latin typeface="Courier New" pitchFamily="49" charset="0"/>
              <a:ea typeface="新細明體" pitchFamily="18" charset="-120"/>
              <a:cs typeface="Courier New" pitchFamily="49" charset="0"/>
            </a:endParaRPr>
          </a:p>
        </p:txBody>
      </p:sp>
      <p:sp>
        <p:nvSpPr>
          <p:cNvPr id="4100" name="Text Box 6"/>
          <p:cNvSpPr txBox="1">
            <a:spLocks noChangeArrowheads="1"/>
          </p:cNvSpPr>
          <p:nvPr/>
        </p:nvSpPr>
        <p:spPr bwMode="auto">
          <a:xfrm>
            <a:off x="981077" y="3208339"/>
            <a:ext cx="57626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1</a:t>
            </a:r>
          </a:p>
        </p:txBody>
      </p:sp>
      <p:sp>
        <p:nvSpPr>
          <p:cNvPr id="4101" name="Text Box 7"/>
          <p:cNvSpPr txBox="1">
            <a:spLocks noChangeArrowheads="1"/>
          </p:cNvSpPr>
          <p:nvPr/>
        </p:nvSpPr>
        <p:spPr bwMode="auto">
          <a:xfrm>
            <a:off x="2428877" y="3810002"/>
            <a:ext cx="57626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2</a:t>
            </a:r>
          </a:p>
        </p:txBody>
      </p:sp>
      <p:sp>
        <p:nvSpPr>
          <p:cNvPr id="4102" name="Text Box 8"/>
          <p:cNvSpPr txBox="1">
            <a:spLocks noChangeArrowheads="1"/>
          </p:cNvSpPr>
          <p:nvPr/>
        </p:nvSpPr>
        <p:spPr bwMode="auto">
          <a:xfrm>
            <a:off x="5214938" y="4351339"/>
            <a:ext cx="5762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3</a:t>
            </a:r>
          </a:p>
        </p:txBody>
      </p:sp>
      <p:sp>
        <p:nvSpPr>
          <p:cNvPr id="4103" name="Text Box 9"/>
          <p:cNvSpPr txBox="1">
            <a:spLocks noChangeArrowheads="1"/>
          </p:cNvSpPr>
          <p:nvPr/>
        </p:nvSpPr>
        <p:spPr bwMode="auto">
          <a:xfrm>
            <a:off x="2132013" y="5208589"/>
            <a:ext cx="5762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4</a:t>
            </a:r>
          </a:p>
        </p:txBody>
      </p:sp>
      <p:sp>
        <p:nvSpPr>
          <p:cNvPr id="4104" name="Text Box 10"/>
          <p:cNvSpPr txBox="1">
            <a:spLocks noChangeArrowheads="1"/>
          </p:cNvSpPr>
          <p:nvPr/>
        </p:nvSpPr>
        <p:spPr bwMode="auto">
          <a:xfrm>
            <a:off x="928688" y="5994402"/>
            <a:ext cx="5762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5</a:t>
            </a:r>
          </a:p>
        </p:txBody>
      </p:sp>
      <p:sp>
        <p:nvSpPr>
          <p:cNvPr id="4105" name="Text Box 11"/>
          <p:cNvSpPr txBox="1">
            <a:spLocks noChangeArrowheads="1"/>
          </p:cNvSpPr>
          <p:nvPr/>
        </p:nvSpPr>
        <p:spPr bwMode="auto">
          <a:xfrm>
            <a:off x="2143127" y="6851652"/>
            <a:ext cx="57626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6</a:t>
            </a:r>
          </a:p>
        </p:txBody>
      </p:sp>
      <p:sp>
        <p:nvSpPr>
          <p:cNvPr id="4106" name="Text Box 12"/>
          <p:cNvSpPr txBox="1">
            <a:spLocks noChangeArrowheads="1"/>
          </p:cNvSpPr>
          <p:nvPr/>
        </p:nvSpPr>
        <p:spPr bwMode="auto">
          <a:xfrm>
            <a:off x="3357563" y="7423151"/>
            <a:ext cx="5762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7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</Words>
  <Application>Microsoft Office PowerPoint</Application>
  <PresentationFormat>A4 Paper (210x297 mm)</PresentationFormat>
  <Paragraphs>1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3</cp:revision>
  <dcterms:created xsi:type="dcterms:W3CDTF">2011-04-07T14:03:02Z</dcterms:created>
  <dcterms:modified xsi:type="dcterms:W3CDTF">2011-04-08T17:46:08Z</dcterms:modified>
</cp:coreProperties>
</file>